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 varScale="1">
        <p:scale>
          <a:sx n="117" d="100"/>
          <a:sy n="117" d="100"/>
        </p:scale>
        <p:origin x="-120" y="-27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415C0-4488-4E91-8E26-841BD46C64A9}" type="datetimeFigureOut">
              <a:rPr lang="en-US" smtClean="0"/>
              <a:t>6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655B4-08E0-47F1-A04F-E6B61E4239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92129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415C0-4488-4E91-8E26-841BD46C64A9}" type="datetimeFigureOut">
              <a:rPr lang="en-US" smtClean="0"/>
              <a:t>6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655B4-08E0-47F1-A04F-E6B61E4239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82065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415C0-4488-4E91-8E26-841BD46C64A9}" type="datetimeFigureOut">
              <a:rPr lang="en-US" smtClean="0"/>
              <a:t>6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655B4-08E0-47F1-A04F-E6B61E4239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23987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415C0-4488-4E91-8E26-841BD46C64A9}" type="datetimeFigureOut">
              <a:rPr lang="en-US" smtClean="0"/>
              <a:t>6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655B4-08E0-47F1-A04F-E6B61E4239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60262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415C0-4488-4E91-8E26-841BD46C64A9}" type="datetimeFigureOut">
              <a:rPr lang="en-US" smtClean="0"/>
              <a:t>6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655B4-08E0-47F1-A04F-E6B61E4239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15071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415C0-4488-4E91-8E26-841BD46C64A9}" type="datetimeFigureOut">
              <a:rPr lang="en-US" smtClean="0"/>
              <a:t>6/2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655B4-08E0-47F1-A04F-E6B61E4239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1441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415C0-4488-4E91-8E26-841BD46C64A9}" type="datetimeFigureOut">
              <a:rPr lang="en-US" smtClean="0"/>
              <a:t>6/24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655B4-08E0-47F1-A04F-E6B61E4239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78786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415C0-4488-4E91-8E26-841BD46C64A9}" type="datetimeFigureOut">
              <a:rPr lang="en-US" smtClean="0"/>
              <a:t>6/24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655B4-08E0-47F1-A04F-E6B61E4239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81898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415C0-4488-4E91-8E26-841BD46C64A9}" type="datetimeFigureOut">
              <a:rPr lang="en-US" smtClean="0"/>
              <a:t>6/24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655B4-08E0-47F1-A04F-E6B61E4239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03817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415C0-4488-4E91-8E26-841BD46C64A9}" type="datetimeFigureOut">
              <a:rPr lang="en-US" smtClean="0"/>
              <a:t>6/2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655B4-08E0-47F1-A04F-E6B61E4239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53558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415C0-4488-4E91-8E26-841BD46C64A9}" type="datetimeFigureOut">
              <a:rPr lang="en-US" smtClean="0"/>
              <a:t>6/2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E655B4-08E0-47F1-A04F-E6B61E4239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6843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6415C0-4488-4E91-8E26-841BD46C64A9}" type="datetimeFigureOut">
              <a:rPr lang="en-US" smtClean="0"/>
              <a:t>6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E655B4-08E0-47F1-A04F-E6B61E4239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09814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50314" y="5867400"/>
            <a:ext cx="8850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ormalized reads count:  log2(1 + </a:t>
            </a:r>
            <a:r>
              <a:rPr lang="en-US" dirty="0" err="1" smtClean="0"/>
              <a:t>raw_read_count</a:t>
            </a:r>
            <a:r>
              <a:rPr lang="en-US" dirty="0" smtClean="0"/>
              <a:t> * 100000/(</a:t>
            </a:r>
            <a:r>
              <a:rPr lang="en-US" dirty="0" err="1" smtClean="0"/>
              <a:t>reads_mapped_to</a:t>
            </a:r>
            <a:r>
              <a:rPr lang="en-US" dirty="0" err="1"/>
              <a:t>_</a:t>
            </a:r>
            <a:r>
              <a:rPr lang="en-US" dirty="0" err="1" smtClean="0"/>
              <a:t>miRBase</a:t>
            </a:r>
            <a:r>
              <a:rPr lang="en-US" dirty="0" smtClean="0"/>
              <a:t>) )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509841" y="2105106"/>
            <a:ext cx="1262910" cy="369332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dirty="0" smtClean="0"/>
              <a:t>1 hr, N=354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469997" y="2052766"/>
            <a:ext cx="1694695" cy="369332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dirty="0" smtClean="0"/>
              <a:t>Baseline, N=242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6477000" y="2133600"/>
            <a:ext cx="1379930" cy="369332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dirty="0" smtClean="0"/>
              <a:t>24 hr, N=252</a:t>
            </a:r>
            <a:endParaRPr lang="en-US" dirty="0"/>
          </a:p>
        </p:txBody>
      </p:sp>
      <p:pic>
        <p:nvPicPr>
          <p:cNvPr id="1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8000" y="2606175"/>
            <a:ext cx="2669993" cy="26580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606175"/>
            <a:ext cx="2772300" cy="27324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0" y="2606175"/>
            <a:ext cx="2591742" cy="25686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Rectangle 9"/>
          <p:cNvSpPr/>
          <p:nvPr/>
        </p:nvSpPr>
        <p:spPr>
          <a:xfrm>
            <a:off x="609600" y="457200"/>
            <a:ext cx="625433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dirty="0" smtClean="0">
                <a:solidFill>
                  <a:prstClr val="black"/>
                </a:solidFill>
              </a:rPr>
              <a:t>S3 Figure A: </a:t>
            </a:r>
            <a:r>
              <a:rPr lang="en-US" dirty="0">
                <a:solidFill>
                  <a:prstClr val="black"/>
                </a:solidFill>
              </a:rPr>
              <a:t>Pair-wise Correlations of Normalized miRNA Counts Between Two Pipelines</a:t>
            </a:r>
          </a:p>
        </p:txBody>
      </p:sp>
    </p:spTree>
    <p:extLst>
      <p:ext uri="{BB962C8B-B14F-4D97-AF65-F5344CB8AC3E}">
        <p14:creationId xmlns:p14="http://schemas.microsoft.com/office/powerpoint/2010/main" val="7018941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250314" y="5867400"/>
            <a:ext cx="878753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ormalized reads count:  log2(1 + </a:t>
            </a:r>
            <a:r>
              <a:rPr lang="en-US" dirty="0" err="1" smtClean="0"/>
              <a:t>raw_read_count</a:t>
            </a:r>
            <a:r>
              <a:rPr lang="en-US" dirty="0" smtClean="0"/>
              <a:t> * 100000/(</a:t>
            </a:r>
            <a:r>
              <a:rPr lang="en-US" dirty="0" err="1" smtClean="0"/>
              <a:t>reads_mapped_to</a:t>
            </a:r>
            <a:r>
              <a:rPr lang="en-US" dirty="0" err="1"/>
              <a:t>_</a:t>
            </a:r>
            <a:r>
              <a:rPr lang="en-US" dirty="0" err="1" smtClean="0"/>
              <a:t>miRBase</a:t>
            </a:r>
            <a:r>
              <a:rPr lang="en-US" dirty="0" smtClean="0"/>
              <a:t>) )</a:t>
            </a:r>
          </a:p>
          <a:p>
            <a:r>
              <a:rPr lang="en-US" dirty="0" smtClean="0"/>
              <a:t> </a:t>
            </a:r>
            <a:endParaRPr lang="en-US" b="1" dirty="0">
              <a:solidFill>
                <a:srgbClr val="0000FF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573449" y="2057000"/>
            <a:ext cx="1262910" cy="369332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dirty="0" smtClean="0"/>
              <a:t>1 hr, N=243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469997" y="2052766"/>
            <a:ext cx="1694695" cy="369332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dirty="0" smtClean="0"/>
              <a:t>Baseline, N=167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6717524" y="2047313"/>
            <a:ext cx="1379930" cy="369332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dirty="0" smtClean="0"/>
              <a:t>24 hr, N=115</a:t>
            </a:r>
            <a:endParaRPr lang="en-US" dirty="0"/>
          </a:p>
        </p:txBody>
      </p:sp>
      <p:pic>
        <p:nvPicPr>
          <p:cNvPr id="15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9398" y="2514600"/>
            <a:ext cx="2753351" cy="27441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492661"/>
            <a:ext cx="2756881" cy="27660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" name="Picture 6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72200" y="2492661"/>
            <a:ext cx="2759952" cy="27323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Rectangle 17"/>
          <p:cNvSpPr/>
          <p:nvPr/>
        </p:nvSpPr>
        <p:spPr>
          <a:xfrm>
            <a:off x="609600" y="457200"/>
            <a:ext cx="78486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dirty="0" smtClean="0">
                <a:solidFill>
                  <a:prstClr val="black"/>
                </a:solidFill>
              </a:rPr>
              <a:t>S3 Figure B: </a:t>
            </a:r>
            <a:r>
              <a:rPr lang="en-US" dirty="0">
                <a:solidFill>
                  <a:prstClr val="black"/>
                </a:solidFill>
              </a:rPr>
              <a:t>Pair-wise Correlations of Normalized miRNA Counts Between Two </a:t>
            </a:r>
            <a:r>
              <a:rPr lang="en-US" dirty="0" smtClean="0">
                <a:solidFill>
                  <a:prstClr val="black"/>
                </a:solidFill>
              </a:rPr>
              <a:t>Pipelines for miRNA with &gt;=5 raw read counts in at least 1 sample</a:t>
            </a:r>
            <a:endParaRPr lang="en-US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652545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8</Words>
  <Application>Microsoft Office PowerPoint</Application>
  <PresentationFormat>On-screen Show (4:3)</PresentationFormat>
  <Paragraphs>11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Mayo Clini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ushar Patel</dc:creator>
  <cp:lastModifiedBy> </cp:lastModifiedBy>
  <cp:revision>2</cp:revision>
  <dcterms:created xsi:type="dcterms:W3CDTF">2016-05-09T23:55:48Z</dcterms:created>
  <dcterms:modified xsi:type="dcterms:W3CDTF">2016-06-24T15:50:30Z</dcterms:modified>
</cp:coreProperties>
</file>